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0" d="100"/>
          <a:sy n="70" d="100"/>
        </p:scale>
        <p:origin x="324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4311CB3-C384-433D-A37A-AF669938B9C8}" type="datetimeFigureOut">
              <a:rPr lang="en-IN" smtClean="0"/>
              <a:t>03-01-2026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5C0F43-1E5B-481E-9CD8-425FB27379A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043040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65C0F43-1E5B-481E-9CD8-425FB27379AE}" type="slidenum">
              <a:rPr lang="en-IN" smtClean="0"/>
              <a:t>1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273980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F5160-6D2E-41E9-96A2-6D08869CB746}" type="datetimeFigureOut">
              <a:rPr lang="en-IN" smtClean="0"/>
              <a:t>03-01-202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A69E96-8377-4B76-A761-BB75DECBA5D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340222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F5160-6D2E-41E9-96A2-6D08869CB746}" type="datetimeFigureOut">
              <a:rPr lang="en-IN" smtClean="0"/>
              <a:t>03-01-202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A69E96-8377-4B76-A761-BB75DECBA5D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274618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F5160-6D2E-41E9-96A2-6D08869CB746}" type="datetimeFigureOut">
              <a:rPr lang="en-IN" smtClean="0"/>
              <a:t>03-01-202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A69E96-8377-4B76-A761-BB75DECBA5D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037865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F5160-6D2E-41E9-96A2-6D08869CB746}" type="datetimeFigureOut">
              <a:rPr lang="en-IN" smtClean="0"/>
              <a:t>03-01-202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A69E96-8377-4B76-A761-BB75DECBA5D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430449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F5160-6D2E-41E9-96A2-6D08869CB746}" type="datetimeFigureOut">
              <a:rPr lang="en-IN" smtClean="0"/>
              <a:t>03-01-202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A69E96-8377-4B76-A761-BB75DECBA5D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855534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F5160-6D2E-41E9-96A2-6D08869CB746}" type="datetimeFigureOut">
              <a:rPr lang="en-IN" smtClean="0"/>
              <a:t>03-01-2026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A69E96-8377-4B76-A761-BB75DECBA5D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177939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F5160-6D2E-41E9-96A2-6D08869CB746}" type="datetimeFigureOut">
              <a:rPr lang="en-IN" smtClean="0"/>
              <a:t>03-01-2026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A69E96-8377-4B76-A761-BB75DECBA5D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501180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F5160-6D2E-41E9-96A2-6D08869CB746}" type="datetimeFigureOut">
              <a:rPr lang="en-IN" smtClean="0"/>
              <a:t>03-01-2026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A69E96-8377-4B76-A761-BB75DECBA5D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783345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F5160-6D2E-41E9-96A2-6D08869CB746}" type="datetimeFigureOut">
              <a:rPr lang="en-IN" smtClean="0"/>
              <a:t>03-01-2026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A69E96-8377-4B76-A761-BB75DECBA5D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744310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F5160-6D2E-41E9-96A2-6D08869CB746}" type="datetimeFigureOut">
              <a:rPr lang="en-IN" smtClean="0"/>
              <a:t>03-01-2026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A69E96-8377-4B76-A761-BB75DECBA5D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750712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F5160-6D2E-41E9-96A2-6D08869CB746}" type="datetimeFigureOut">
              <a:rPr lang="en-IN" smtClean="0"/>
              <a:t>03-01-2026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A69E96-8377-4B76-A761-BB75DECBA5D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419585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5F5160-6D2E-41E9-96A2-6D08869CB746}" type="datetimeFigureOut">
              <a:rPr lang="en-IN" smtClean="0"/>
              <a:t>03-01-202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A69E96-8377-4B76-A761-BB75DECBA5D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744633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TextBox 31">
            <a:extLst>
              <a:ext uri="{FF2B5EF4-FFF2-40B4-BE49-F238E27FC236}">
                <a16:creationId xmlns:a16="http://schemas.microsoft.com/office/drawing/2014/main" id="{A3283764-6DF7-6228-7860-57C3055703B9}"/>
              </a:ext>
            </a:extLst>
          </p:cNvPr>
          <p:cNvSpPr txBox="1"/>
          <p:nvPr/>
        </p:nvSpPr>
        <p:spPr>
          <a:xfrm>
            <a:off x="342520" y="6008491"/>
            <a:ext cx="621503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racterisatio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 Chatham and Rs fruits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amounts of anthocyanins in red-ripe fruits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rizontal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Longitudinal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perimeters of red-ripe fruits. The data are expressed as mean ± SE (n ≥ 3). 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9E7EC41D-8964-8E67-0F88-0FA8501A1DB2}"/>
              </a:ext>
            </a:extLst>
          </p:cNvPr>
          <p:cNvGrpSpPr/>
          <p:nvPr/>
        </p:nvGrpSpPr>
        <p:grpSpPr>
          <a:xfrm>
            <a:off x="657000" y="1654865"/>
            <a:ext cx="5861921" cy="3739961"/>
            <a:chOff x="657000" y="1654865"/>
            <a:chExt cx="5861921" cy="3739961"/>
          </a:xfrm>
        </p:grpSpPr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252BC086-8916-9E43-FADB-22FE42863469}"/>
                </a:ext>
              </a:extLst>
            </p:cNvPr>
            <p:cNvGrpSpPr/>
            <p:nvPr/>
          </p:nvGrpSpPr>
          <p:grpSpPr>
            <a:xfrm>
              <a:off x="657000" y="1654865"/>
              <a:ext cx="5861921" cy="3739961"/>
              <a:chOff x="657000" y="1654865"/>
              <a:chExt cx="5861921" cy="3739961"/>
            </a:xfrm>
          </p:grpSpPr>
          <p:graphicFrame>
            <p:nvGraphicFramePr>
              <p:cNvPr id="4" name="Object 3">
                <a:extLst>
                  <a:ext uri="{FF2B5EF4-FFF2-40B4-BE49-F238E27FC236}">
                    <a16:creationId xmlns:a16="http://schemas.microsoft.com/office/drawing/2014/main" id="{86927B7D-0F13-E57B-E546-A0F78B37A4BF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165012262"/>
                  </p:ext>
                </p:extLst>
              </p:nvPr>
            </p:nvGraphicFramePr>
            <p:xfrm>
              <a:off x="657000" y="1654865"/>
              <a:ext cx="2772000" cy="3140226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5.0 Graph" r:id="rId3" imgW="3621102" imgH="4102694" progId="SigmaPlotGraphicObject.15">
                      <p:embed/>
                    </p:oleObj>
                  </mc:Choice>
                  <mc:Fallback>
                    <p:oleObj name="SPW 15.0 Graph" r:id="rId3" imgW="3621102" imgH="4102694" progId="SigmaPlotGraphicObject.15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4"/>
                          <a:stretch>
                            <a:fillRect/>
                          </a:stretch>
                        </p:blipFill>
                        <p:spPr>
                          <a:xfrm>
                            <a:off x="657000" y="1654865"/>
                            <a:ext cx="2772000" cy="3140226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2" name="Object 1">
                <a:extLst>
                  <a:ext uri="{FF2B5EF4-FFF2-40B4-BE49-F238E27FC236}">
                    <a16:creationId xmlns:a16="http://schemas.microsoft.com/office/drawing/2014/main" id="{15F93814-6EC2-F1B7-D6A8-2781669FC436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718767876"/>
                  </p:ext>
                </p:extLst>
              </p:nvPr>
            </p:nvGraphicFramePr>
            <p:xfrm>
              <a:off x="3582847" y="1654865"/>
              <a:ext cx="2936074" cy="3739961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5.0 Graph" r:id="rId5" imgW="3863255" imgH="4921001" progId="SigmaPlotGraphicObject.15">
                      <p:embed/>
                    </p:oleObj>
                  </mc:Choice>
                  <mc:Fallback>
                    <p:oleObj name="SPW 15.0 Graph" r:id="rId5" imgW="3863255" imgH="4921001" progId="SigmaPlotGraphicObject.15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6"/>
                          <a:stretch>
                            <a:fillRect/>
                          </a:stretch>
                        </p:blipFill>
                        <p:spPr>
                          <a:xfrm>
                            <a:off x="3582847" y="1654865"/>
                            <a:ext cx="2936074" cy="3739961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CFB9F8D8-8607-7F9D-B6B1-A7927896EF96}"/>
                  </a:ext>
                </a:extLst>
              </p:cNvPr>
              <p:cNvSpPr txBox="1"/>
              <p:nvPr/>
            </p:nvSpPr>
            <p:spPr>
              <a:xfrm>
                <a:off x="1250989" y="1947543"/>
                <a:ext cx="35137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en-IN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8F134A43-9FD2-A285-CB01-27E74CD82570}"/>
                  </a:ext>
                </a:extLst>
              </p:cNvPr>
              <p:cNvSpPr txBox="1"/>
              <p:nvPr/>
            </p:nvSpPr>
            <p:spPr>
              <a:xfrm>
                <a:off x="4045611" y="1947543"/>
                <a:ext cx="35137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IN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C0F67E9F-49AC-96D7-54F4-EAD949F0F8AC}"/>
                </a:ext>
              </a:extLst>
            </p:cNvPr>
            <p:cNvSpPr txBox="1"/>
            <p:nvPr/>
          </p:nvSpPr>
          <p:spPr>
            <a:xfrm>
              <a:off x="2466339" y="1977668"/>
              <a:ext cx="28725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*</a:t>
              </a:r>
              <a:endParaRPr lang="en-IN" sz="1600" dirty="0"/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4131C574-FC26-745F-F983-4930BA3678A8}"/>
                </a:ext>
              </a:extLst>
            </p:cNvPr>
            <p:cNvSpPr txBox="1"/>
            <p:nvPr/>
          </p:nvSpPr>
          <p:spPr>
            <a:xfrm>
              <a:off x="4804758" y="2040503"/>
              <a:ext cx="28725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*</a:t>
              </a:r>
              <a:endParaRPr lang="en-IN" sz="1600" dirty="0"/>
            </a:p>
          </p:txBody>
        </p:sp>
      </p:grpSp>
    </p:spTree>
    <p:extLst>
      <p:ext uri="{BB962C8B-B14F-4D97-AF65-F5344CB8AC3E}">
        <p14:creationId xmlns:p14="http://schemas.microsoft.com/office/powerpoint/2010/main" val="32409897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07</TotalTime>
  <Words>54</Words>
  <Application>Microsoft Office PowerPoint</Application>
  <PresentationFormat>A4 Paper (210x297 mm)</PresentationFormat>
  <Paragraphs>6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SPW 15.0 Graph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ameshwar Sharma</dc:creator>
  <cp:lastModifiedBy>Rameshwar Sharma</cp:lastModifiedBy>
  <cp:revision>11</cp:revision>
  <dcterms:created xsi:type="dcterms:W3CDTF">2025-09-17T06:19:04Z</dcterms:created>
  <dcterms:modified xsi:type="dcterms:W3CDTF">2026-01-03T09:01:31Z</dcterms:modified>
</cp:coreProperties>
</file>